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25" r:id="rId2"/>
    <p:sldId id="32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78" d="100"/>
          <a:sy n="78" d="100"/>
        </p:scale>
        <p:origin x="77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B17723-BBB5-A64E-BB0C-71158C9E246F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F349E5-ADB8-F740-BB61-E612F06E9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8859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.C.glabrata</a:t>
            </a:r>
          </a:p>
          <a:p>
            <a:r>
              <a:rPr lang="en-US" dirty="0"/>
              <a:t>2.Candida albicans</a:t>
            </a:r>
          </a:p>
          <a:p>
            <a:r>
              <a:rPr lang="en-US" dirty="0"/>
              <a:t>3.C.krusei</a:t>
            </a:r>
          </a:p>
          <a:p>
            <a:r>
              <a:rPr lang="en-US" dirty="0"/>
              <a:t>4.C.tropical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F349E5-ADB8-F740-BB61-E612F06E9A0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077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21FD5-455E-AD05-370A-367CA719D8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71EF5D-FE60-F286-BDCF-C70534581D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06ADF7-7390-8432-E8E1-A6687AB09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EA6ADB-9EBD-F19E-FDB7-653A3D8A6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C0199-5350-07C1-0EF3-766744954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48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CF592-2EAE-AFB4-DB91-84236CA924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413723-C2AE-7E11-FA45-C40041E92D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22E97F-0ECC-EA90-F87C-EAF0E08B6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89D06-D125-E82B-BD42-98C0371B9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392F2-4266-0024-89EC-C49BB31B3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74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A5058B-D2FE-591B-8F23-C8F165656F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6B0770-8F48-0FD1-CD1C-CB5E66E543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33F700-E8DB-953E-4409-6BAD08D8B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3B63D-4E9F-17A4-1783-46A2BE857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D9355-C811-EE6F-D856-5150E75CC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13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80E23-DC80-435E-0D9B-A3F517FF2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3B9F24-209F-894A-028D-2DDD197927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E32B4F-78F6-0C5D-9B6B-8D528D672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A64172-34D1-C7F2-6AF7-CC3AABCE9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9230E-DE34-45CA-3364-C6DE20AFE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972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96E0CF-3E5F-82B3-7E50-6A89DF09A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7D1069-D37D-5C3D-A8D1-C3B5D7F9CB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7B59B7-BA18-9D06-3C35-1776730F7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6938D-FEF0-4F65-1E49-6A714113C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B4136-6110-EECA-38A4-F5CFF4510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887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299225-F6FA-4031-264C-94AE218C12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FC342E-041B-84CB-5474-E936AE95A6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08606F-BE04-7FC6-9273-B697850EAB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C8C6A-CD14-9CC1-50A6-40A4F05BE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6BC799-FDC7-882F-FB3B-24279060A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9E280B-7517-008C-CB76-BC49CC31C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212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EE7DA2-FAAA-EEB2-37E7-2CB20B89D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2B69C8-F5C0-9A45-866C-AE2AC1EBD2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8D391B-B3D4-63E4-6D04-EF1295161F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B493AD-5BAD-B5AA-DC7E-CA98E6D16E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E99DDC-7F8D-4EC4-50AB-78FF753752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C26347-8B47-9AEA-B946-3C69B72A5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25C72F-F752-2449-EB76-30323ED4F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679184-ECEE-0610-F9B0-2BBE10EA0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582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6C4EDB-A1C9-65F4-F00F-0B4AE5AEC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DC1681-7584-1D51-A77D-4F3416190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8ABE98-DDF9-95ED-3474-4A367D0AF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6ED6E3-8950-AC78-5392-BDA512A23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069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284688-30E0-6F0E-6D24-75610304F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93F81C-AA82-19AB-790D-F1596A433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712177-12C1-8A98-1728-ECE02AA48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017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4DA6EE-7390-AEE2-2B58-2848CAFAF7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61AFF9-EABF-5A80-873F-5370500574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FAC416-D1A4-4BC1-3766-EF10EF747E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F4A2C0-745D-E4C9-2B8A-F6F90D075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8A465F-0B71-5D26-CB15-E361DE76D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F9401E-4716-3CCF-365F-BC92FA7DC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8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EC566-0364-D4D4-C4AD-608A0DFB3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3DD003-CB1E-21FB-302B-1D6D0D4822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077FB3-2881-E731-C620-5311CD188E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B95D98-047F-46DA-768F-A1A6446AE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21BE10-1E29-470F-5AA0-E96542A4E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F1DEC5-2EA3-6D99-E86C-0D7241DA4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883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970868-5989-B9E7-7D64-6E958CFB4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9E369F-ADFF-7745-BA46-505AFB1058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D0A4A1-48FA-93CC-7547-1B3EE5EC32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571C91-7269-3544-8979-76A4F6203BB5}" type="datetimeFigureOut">
              <a:rPr lang="en-US" smtClean="0"/>
              <a:t>7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7B07D3-FAB5-3886-C043-04EC9680CB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0F2647-41AF-8BE3-060C-C378B89A33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BE9C2D-5016-6F43-B4FA-9897A393E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485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1106669" y="6337099"/>
            <a:ext cx="683339" cy="365125"/>
          </a:xfrm>
        </p:spPr>
        <p:txBody>
          <a:bodyPr/>
          <a:lstStyle/>
          <a:p>
            <a:r>
              <a:rPr lang="fa-IR" sz="2000" b="1" dirty="0">
                <a:solidFill>
                  <a:schemeClr val="tx1"/>
                </a:solidFill>
                <a:cs typeface="B Nazanin" panose="00000400000000000000" pitchFamily="2" charset="-78"/>
              </a:rPr>
              <a:t>53</a:t>
            </a:r>
            <a:endParaRPr lang="en-US" b="1" dirty="0">
              <a:solidFill>
                <a:schemeClr val="tx1"/>
              </a:solidFill>
              <a:cs typeface="B Nazanin" panose="00000400000000000000" pitchFamily="2" charset="-78"/>
            </a:endParaRPr>
          </a:p>
        </p:txBody>
      </p:sp>
      <p:pic>
        <p:nvPicPr>
          <p:cNvPr id="5" name="Picture 2" descr="C:\Users\Meshkini\Pictures\243-vintage-graph-with-buttons-ppt-background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12192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0077" y="1838787"/>
            <a:ext cx="4795686" cy="4524375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9" name="Rectangle 8"/>
          <p:cNvSpPr/>
          <p:nvPr/>
        </p:nvSpPr>
        <p:spPr>
          <a:xfrm>
            <a:off x="5901075" y="1993153"/>
            <a:ext cx="389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6507828" y="196938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894384" y="196938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430605" y="196938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890283" y="196938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4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8422860" y="1932598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5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8954684" y="1975923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6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9450811" y="196938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7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9983388" y="1993153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8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5870077" y="5830827"/>
            <a:ext cx="7617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bps</a:t>
            </a:r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7725399" y="4733221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90bps</a:t>
            </a:r>
            <a:endParaRPr lang="en-US" dirty="0"/>
          </a:p>
        </p:txBody>
      </p:sp>
      <p:sp>
        <p:nvSpPr>
          <p:cNvPr id="20" name="Rectangle 19"/>
          <p:cNvSpPr/>
          <p:nvPr/>
        </p:nvSpPr>
        <p:spPr>
          <a:xfrm>
            <a:off x="8209601" y="4275128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6bps</a:t>
            </a:r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8727033" y="5405183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2bps</a:t>
            </a:r>
            <a:endParaRPr lang="en-US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2706" y="1838786"/>
            <a:ext cx="4719918" cy="4524375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1329075" y="1777111"/>
            <a:ext cx="3898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1279293" y="5609445"/>
            <a:ext cx="7617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bps</a:t>
            </a:r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>
            <a:off x="1847424" y="1825133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1</a:t>
            </a:r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>
            <a:off x="2295241" y="1807409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2</a:t>
            </a:r>
            <a:endParaRPr lang="en-US" dirty="0"/>
          </a:p>
        </p:txBody>
      </p:sp>
      <p:sp>
        <p:nvSpPr>
          <p:cNvPr id="28" name="Rectangle 27"/>
          <p:cNvSpPr/>
          <p:nvPr/>
        </p:nvSpPr>
        <p:spPr>
          <a:xfrm>
            <a:off x="2770201" y="1791257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</a:t>
            </a:r>
            <a:endParaRPr lang="en-US" dirty="0"/>
          </a:p>
        </p:txBody>
      </p:sp>
      <p:sp>
        <p:nvSpPr>
          <p:cNvPr id="29" name="Rectangle 28"/>
          <p:cNvSpPr/>
          <p:nvPr/>
        </p:nvSpPr>
        <p:spPr>
          <a:xfrm>
            <a:off x="3206318" y="1838786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4</a:t>
            </a:r>
            <a:endParaRPr lang="en-US" dirty="0"/>
          </a:p>
        </p:txBody>
      </p:sp>
      <p:sp>
        <p:nvSpPr>
          <p:cNvPr id="30" name="Rectangle 29"/>
          <p:cNvSpPr/>
          <p:nvPr/>
        </p:nvSpPr>
        <p:spPr>
          <a:xfrm>
            <a:off x="3642693" y="1777111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5</a:t>
            </a:r>
            <a:endParaRPr lang="en-US" dirty="0"/>
          </a:p>
        </p:txBody>
      </p:sp>
      <p:sp>
        <p:nvSpPr>
          <p:cNvPr id="31" name="Rectangle 30"/>
          <p:cNvSpPr/>
          <p:nvPr/>
        </p:nvSpPr>
        <p:spPr>
          <a:xfrm>
            <a:off x="4092395" y="1824299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6</a:t>
            </a:r>
            <a:endParaRPr lang="en-US" sz="1200" b="1" dirty="0">
              <a:ln w="0"/>
              <a:solidFill>
                <a:srgbClr val="FF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4498232" y="1838786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7</a:t>
            </a:r>
            <a:endParaRPr lang="en-US" dirty="0"/>
          </a:p>
        </p:txBody>
      </p:sp>
      <p:sp>
        <p:nvSpPr>
          <p:cNvPr id="33" name="Rectangle 32"/>
          <p:cNvSpPr/>
          <p:nvPr/>
        </p:nvSpPr>
        <p:spPr>
          <a:xfrm>
            <a:off x="5034453" y="1850696"/>
            <a:ext cx="319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n w="0"/>
                <a:solidFill>
                  <a:srgbClr val="FF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8</a:t>
            </a:r>
            <a:endParaRPr lang="en-US" dirty="0"/>
          </a:p>
        </p:txBody>
      </p:sp>
      <p:sp>
        <p:nvSpPr>
          <p:cNvPr id="34" name="Rectangle 33"/>
          <p:cNvSpPr/>
          <p:nvPr/>
        </p:nvSpPr>
        <p:spPr>
          <a:xfrm>
            <a:off x="2016318" y="3425080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6bps</a:t>
            </a:r>
            <a:endParaRPr lang="en-US" dirty="0"/>
          </a:p>
        </p:txBody>
      </p:sp>
      <p:sp>
        <p:nvSpPr>
          <p:cNvPr id="35" name="Rectangle 34"/>
          <p:cNvSpPr/>
          <p:nvPr/>
        </p:nvSpPr>
        <p:spPr>
          <a:xfrm>
            <a:off x="3802352" y="2913245"/>
            <a:ext cx="958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59bps</a:t>
            </a:r>
            <a:endParaRPr lang="en-US" dirty="0"/>
          </a:p>
        </p:txBody>
      </p:sp>
      <p:sp>
        <p:nvSpPr>
          <p:cNvPr id="36" name="Rectangle 35"/>
          <p:cNvSpPr/>
          <p:nvPr/>
        </p:nvSpPr>
        <p:spPr>
          <a:xfrm>
            <a:off x="2446624" y="4363889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2bps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907859" y="3259477"/>
            <a:ext cx="12763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dida albicans</a:t>
            </a:r>
            <a:endParaRPr lang="en-US" sz="12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3760573" y="2720848"/>
            <a:ext cx="74090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krusei</a:t>
            </a:r>
            <a:endParaRPr lang="en-US" sz="12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2327845" y="4683977"/>
            <a:ext cx="9685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glabrata</a:t>
            </a:r>
            <a:endParaRPr lang="en-US" sz="14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7491936" y="5043452"/>
            <a:ext cx="12747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parapsilosis</a:t>
            </a:r>
            <a:endParaRPr lang="en-US" sz="1400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8491088" y="5688981"/>
            <a:ext cx="11913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glabrata</a:t>
            </a:r>
            <a:endParaRPr lang="en-US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7631082" y="4008304"/>
            <a:ext cx="18197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dida albicans</a:t>
            </a:r>
            <a:endParaRPr lang="en-US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1588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AEC51AE-F2A1-380D-2578-1E218252DA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2386" y="1816668"/>
            <a:ext cx="5768684" cy="41269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2DA074F-2133-90E7-F78F-7FF6A8CC2E31}"/>
              </a:ext>
            </a:extLst>
          </p:cNvPr>
          <p:cNvSpPr txBox="1"/>
          <p:nvPr/>
        </p:nvSpPr>
        <p:spPr>
          <a:xfrm>
            <a:off x="1240825" y="1951672"/>
            <a:ext cx="177010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.</a:t>
            </a:r>
            <a:r>
              <a:rPr lang="en-US" i="1" dirty="0"/>
              <a:t>C.glabrata</a:t>
            </a:r>
          </a:p>
          <a:p>
            <a:r>
              <a:rPr lang="en-US" dirty="0"/>
              <a:t>2</a:t>
            </a:r>
            <a:r>
              <a:rPr lang="en-US" i="1" dirty="0"/>
              <a:t>.C.albicans</a:t>
            </a:r>
          </a:p>
          <a:p>
            <a:r>
              <a:rPr lang="en-US" dirty="0"/>
              <a:t>3.</a:t>
            </a:r>
            <a:r>
              <a:rPr lang="en-US" i="1" dirty="0"/>
              <a:t>C.krusei</a:t>
            </a:r>
          </a:p>
          <a:p>
            <a:r>
              <a:rPr lang="en-US" dirty="0"/>
              <a:t>4</a:t>
            </a:r>
            <a:r>
              <a:rPr lang="en-US" i="1" dirty="0"/>
              <a:t>.C.tropicalis</a:t>
            </a:r>
          </a:p>
        </p:txBody>
      </p:sp>
    </p:spTree>
    <p:extLst>
      <p:ext uri="{BB962C8B-B14F-4D97-AF65-F5344CB8AC3E}">
        <p14:creationId xmlns:p14="http://schemas.microsoft.com/office/powerpoint/2010/main" val="2423605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83</Words>
  <Application>Microsoft Office PowerPoint</Application>
  <PresentationFormat>Widescreen</PresentationFormat>
  <Paragraphs>4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B Nazanin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Roudbary</dc:creator>
  <cp:lastModifiedBy>MDPI</cp:lastModifiedBy>
  <cp:revision>2</cp:revision>
  <dcterms:created xsi:type="dcterms:W3CDTF">2024-06-03T01:06:30Z</dcterms:created>
  <dcterms:modified xsi:type="dcterms:W3CDTF">2024-07-08T10:03:23Z</dcterms:modified>
</cp:coreProperties>
</file>